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2" d="100"/>
          <a:sy n="82" d="100"/>
        </p:scale>
        <p:origin x="-1397" y="-77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0E07D9-267A-488F-B86C-DBDF387B3A10}" type="datetimeFigureOut">
              <a:rPr lang="en-US" smtClean="0"/>
              <a:t>4/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5B8B01-7794-4118-9A4A-9CDE3DF39A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01181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0E07D9-267A-488F-B86C-DBDF387B3A10}" type="datetimeFigureOut">
              <a:rPr lang="en-US" smtClean="0"/>
              <a:t>4/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5B8B01-7794-4118-9A4A-9CDE3DF39A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24441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0E07D9-267A-488F-B86C-DBDF387B3A10}" type="datetimeFigureOut">
              <a:rPr lang="en-US" smtClean="0"/>
              <a:t>4/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5B8B01-7794-4118-9A4A-9CDE3DF39A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43615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0E07D9-267A-488F-B86C-DBDF387B3A10}" type="datetimeFigureOut">
              <a:rPr lang="en-US" smtClean="0"/>
              <a:t>4/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5B8B01-7794-4118-9A4A-9CDE3DF39A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9068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0E07D9-267A-488F-B86C-DBDF387B3A10}" type="datetimeFigureOut">
              <a:rPr lang="en-US" smtClean="0"/>
              <a:t>4/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5B8B01-7794-4118-9A4A-9CDE3DF39A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29859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0E07D9-267A-488F-B86C-DBDF387B3A10}" type="datetimeFigureOut">
              <a:rPr lang="en-US" smtClean="0"/>
              <a:t>4/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5B8B01-7794-4118-9A4A-9CDE3DF39A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17146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0E07D9-267A-488F-B86C-DBDF387B3A10}" type="datetimeFigureOut">
              <a:rPr lang="en-US" smtClean="0"/>
              <a:t>4/2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5B8B01-7794-4118-9A4A-9CDE3DF39A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92137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0E07D9-267A-488F-B86C-DBDF387B3A10}" type="datetimeFigureOut">
              <a:rPr lang="en-US" smtClean="0"/>
              <a:t>4/2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5B8B01-7794-4118-9A4A-9CDE3DF39A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2313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0E07D9-267A-488F-B86C-DBDF387B3A10}" type="datetimeFigureOut">
              <a:rPr lang="en-US" smtClean="0"/>
              <a:t>4/2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5B8B01-7794-4118-9A4A-9CDE3DF39A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4507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0E07D9-267A-488F-B86C-DBDF387B3A10}" type="datetimeFigureOut">
              <a:rPr lang="en-US" smtClean="0"/>
              <a:t>4/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5B8B01-7794-4118-9A4A-9CDE3DF39A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73431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0E07D9-267A-488F-B86C-DBDF387B3A10}" type="datetimeFigureOut">
              <a:rPr lang="en-US" smtClean="0"/>
              <a:t>4/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5B8B01-7794-4118-9A4A-9CDE3DF39A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81203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0E07D9-267A-488F-B86C-DBDF387B3A10}" type="datetimeFigureOut">
              <a:rPr lang="en-US" smtClean="0"/>
              <a:t>4/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5B8B01-7794-4118-9A4A-9CDE3DF39A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20486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38300" y="0"/>
            <a:ext cx="5846600" cy="685800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228600" y="76200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57200"/>
            <a:r>
              <a:rPr lang="en-US" dirty="0">
                <a:solidFill>
                  <a:prstClr val="black"/>
                </a:solidFill>
                <a:latin typeface="Arial"/>
                <a:cs typeface="Arial"/>
              </a:rPr>
              <a:t>Figure 3A</a:t>
            </a:r>
          </a:p>
        </p:txBody>
      </p:sp>
    </p:spTree>
    <p:extLst>
      <p:ext uri="{BB962C8B-B14F-4D97-AF65-F5344CB8AC3E}">
        <p14:creationId xmlns:p14="http://schemas.microsoft.com/office/powerpoint/2010/main" val="417511393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43000" y="457200"/>
            <a:ext cx="7499396" cy="6096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76200" y="97199"/>
            <a:ext cx="11854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57200"/>
            <a:r>
              <a:rPr lang="en-US" dirty="0">
                <a:solidFill>
                  <a:prstClr val="black"/>
                </a:solidFill>
                <a:latin typeface="Arial"/>
                <a:cs typeface="Arial"/>
              </a:rPr>
              <a:t>Figure 3B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3124200" y="87868"/>
            <a:ext cx="5918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lk1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6629400" y="108476"/>
            <a:ext cx="5918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lk2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2042840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38199" y="296199"/>
            <a:ext cx="8077429" cy="640940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3124200" y="87868"/>
            <a:ext cx="5918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lk3</a:t>
            </a:r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6324600" y="55602"/>
            <a:ext cx="5918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lk5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8499156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4400" y="387685"/>
            <a:ext cx="7772400" cy="631791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3124200" y="87868"/>
            <a:ext cx="5918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lk6</a:t>
            </a:r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6400800" y="62605"/>
            <a:ext cx="9193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VEGFR2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7926131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2000" y="287729"/>
            <a:ext cx="7772400" cy="64940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3124200" y="87868"/>
            <a:ext cx="7216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mFlt1</a:t>
            </a:r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6629400" y="55602"/>
            <a:ext cx="6270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Flt1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7985856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9600" y="76200"/>
            <a:ext cx="8077200" cy="670890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3124200" y="87868"/>
            <a:ext cx="8386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dirty="0" smtClean="0"/>
              <a:t>β</a:t>
            </a:r>
            <a:r>
              <a:rPr lang="en-US" dirty="0" smtClean="0"/>
              <a:t>-actin</a:t>
            </a:r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6019800" y="85540"/>
            <a:ext cx="172027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l-GR" dirty="0" smtClean="0"/>
              <a:t>β</a:t>
            </a:r>
            <a:r>
              <a:rPr lang="en-US" dirty="0" smtClean="0"/>
              <a:t>-actin</a:t>
            </a:r>
          </a:p>
          <a:p>
            <a:pPr algn="ctr"/>
            <a:r>
              <a:rPr lang="en-US" dirty="0" smtClean="0"/>
              <a:t>Higher exposur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2778247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6727" y="228600"/>
            <a:ext cx="8138722" cy="6553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2212614" y="46166"/>
            <a:ext cx="172053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/>
              <a:t>Alk1</a:t>
            </a:r>
          </a:p>
          <a:p>
            <a:pPr algn="ctr"/>
            <a:r>
              <a:rPr lang="en-US" dirty="0" smtClean="0"/>
              <a:t>Higher Exposure</a:t>
            </a:r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6463448" y="49658"/>
            <a:ext cx="5918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lk2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840736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2</TotalTime>
  <Words>22</Words>
  <Application>Microsoft Office PowerPoint</Application>
  <PresentationFormat>On-screen Show (4:3)</PresentationFormat>
  <Paragraphs>16</Paragraphs>
  <Slides>7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8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bhijit S. Dighe</dc:creator>
  <cp:lastModifiedBy>Abhijit S. Dighe</cp:lastModifiedBy>
  <cp:revision>4</cp:revision>
  <dcterms:created xsi:type="dcterms:W3CDTF">2018-03-28T22:25:56Z</dcterms:created>
  <dcterms:modified xsi:type="dcterms:W3CDTF">2018-04-02T16:36:03Z</dcterms:modified>
</cp:coreProperties>
</file>